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sldIdLst>
    <p:sldId id="271" r:id="rId2"/>
  </p:sldIdLst>
  <p:sldSz cx="6858000" cy="9906000" type="A4"/>
  <p:notesSz cx="6797675" cy="9928225"/>
  <p:embeddedFontLst>
    <p:embeddedFont>
      <p:font typeface="Calibri" panose="020F0502020204030204" pitchFamily="34" charset="0"/>
      <p:regular r:id="rId3"/>
      <p:bold r:id="rId4"/>
      <p:italic r:id="rId5"/>
      <p:boldItalic r:id="rId6"/>
    </p:embeddedFont>
  </p:embeddedFont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Bez stylu, bez siatki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Bez stylu, siatka tabeli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Styl jasny 1 — Ak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73A0DAA-6AF3-43AB-8588-CEC1D06C72B9}" styleName="Styl pośredni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Styl jasny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8750" autoAdjust="0"/>
    <p:restoredTop sz="98743" autoAdjust="0"/>
  </p:normalViewPr>
  <p:slideViewPr>
    <p:cSldViewPr>
      <p:cViewPr>
        <p:scale>
          <a:sx n="150" d="100"/>
          <a:sy n="150" d="100"/>
        </p:scale>
        <p:origin x="-72" y="7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font" Target="fonts/font1.fntdata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5" Type="http://schemas.openxmlformats.org/officeDocument/2006/relationships/font" Target="fonts/font3.fntdata"/><Relationship Id="rId10" Type="http://schemas.openxmlformats.org/officeDocument/2006/relationships/tableStyles" Target="tableStyles.xml"/><Relationship Id="rId4" Type="http://schemas.openxmlformats.org/officeDocument/2006/relationships/font" Target="fonts/font2.fntdata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en-US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763564-58FE-4902-91F2-2756B60426B6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1B4E4E-3929-4DFB-BC23-F8D1D5E24DD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0462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494EAD-0C1C-4409-99DC-E0519A0A86EF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DB0BAE-6226-46A7-A103-80BA8B61B05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1586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4972050" y="396704"/>
            <a:ext cx="1543050" cy="8452203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342900" y="396704"/>
            <a:ext cx="4514850" cy="8452203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B9B439-A0F5-4651-A899-1B9D12BFFB11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267547-49EA-4DB2-82D6-210888D804A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333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19BED1-5D24-4F31-929D-578B2E0F4741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017D12-73F1-4AC8-A1E9-4E06F1FE4D9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745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EEA40B-319F-475F-AC1D-69F705519033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7BDF-B290-4E02-831C-6CABE0F6FC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920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5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920DA2-48E3-41D4-9108-BC560EBE7F03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6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07DEBA-55D0-48BD-962E-78841170C93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3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72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7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59D0FE-DC86-4AF1-B05A-81E1B3B88919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8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20994A-6D92-4AC7-9E81-6130244F2A2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215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391CEA-414F-4DFB-A8A8-60C6EB91B6DD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4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B8C949-CB92-4799-BE07-2300137C07C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991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DF0631-ABC1-4E1E-BA10-D1D4944C1CF5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3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35F057-5E8F-4BB8-9172-4EE88F6869A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263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8" y="394410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1ADBA3-FC7F-4BAD-A0E8-C26618055E4B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6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28DCBF-2470-497D-B68B-FDEA76B9FF6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726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A9A89F-15BA-4613-B9BE-23BC8B0B915C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6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C5DF33-E905-4F37-81E4-BAC8E917B08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22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ymbol zastępczy tytułu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l-PL" altLang="en-US" smtClean="0"/>
              <a:t>Kliknij, aby edytować styl</a:t>
            </a:r>
            <a:endParaRPr lang="en-US" altLang="en-US" smtClean="0"/>
          </a:p>
        </p:txBody>
      </p:sp>
      <p:sp>
        <p:nvSpPr>
          <p:cNvPr id="1027" name="Symbol zastępczy tekstu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l-PL" altLang="en-US" smtClean="0"/>
              <a:t>Kliknij, aby edytować style wzorca tekstu</a:t>
            </a:r>
          </a:p>
          <a:p>
            <a:pPr lvl="1"/>
            <a:r>
              <a:rPr lang="pl-PL" altLang="en-US" smtClean="0"/>
              <a:t>Drugi poziom</a:t>
            </a:r>
          </a:p>
          <a:p>
            <a:pPr lvl="2"/>
            <a:r>
              <a:rPr lang="pl-PL" altLang="en-US" smtClean="0"/>
              <a:t>Trzeci poziom</a:t>
            </a:r>
          </a:p>
          <a:p>
            <a:pPr lvl="3"/>
            <a:r>
              <a:rPr lang="pl-PL" altLang="en-US" smtClean="0"/>
              <a:t>Czwarty poziom</a:t>
            </a:r>
          </a:p>
          <a:p>
            <a:pPr lvl="4"/>
            <a:r>
              <a:rPr lang="pl-PL" altLang="en-US" smtClean="0"/>
              <a:t>Piąty poziom</a:t>
            </a:r>
            <a:endParaRPr lang="en-US" altLang="en-US" smtClean="0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35C633D1-5D7C-4432-92F3-63E0A16024BF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D30D53A-61A3-4FF3-9058-691D2F39E07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Grupa 38"/>
          <p:cNvGrpSpPr>
            <a:grpSpLocks/>
          </p:cNvGrpSpPr>
          <p:nvPr/>
        </p:nvGrpSpPr>
        <p:grpSpPr bwMode="auto">
          <a:xfrm>
            <a:off x="833438" y="1065213"/>
            <a:ext cx="5764212" cy="2914650"/>
            <a:chOff x="835946" y="1064568"/>
            <a:chExt cx="4547777" cy="2299731"/>
          </a:xfrm>
        </p:grpSpPr>
        <p:pic>
          <p:nvPicPr>
            <p:cNvPr id="2059" name="Obraz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5946" y="1064568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0" name="Obraz 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81316" y="1064568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1" name="Obraz 5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26686" y="1064568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2" name="Obraz 6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72056" y="1064568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3" name="Obraz 8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5946" y="1646447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4" name="Obraz 9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81316" y="1646447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5" name="Obraz 10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26688" y="1646447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6" name="Obraz 11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72059" y="1646447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7" name="Obraz 13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5946" y="2228326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8" name="Obraz 14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81316" y="2228326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9" name="Obraz 15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26688" y="2228326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0" name="Obraz 16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72059" y="2228326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1" name="Obraz 18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5946" y="2810205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2" name="Obraz 19"/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81317" y="2810205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3" name="Obraz 20"/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26688" y="2810205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4" name="Obraz 21"/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72059" y="2810205"/>
              <a:ext cx="1111664" cy="5540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2051" name="pole tekstowe 37"/>
          <p:cNvSpPr txBox="1">
            <a:spLocks noChangeArrowheads="1"/>
          </p:cNvSpPr>
          <p:nvPr/>
        </p:nvSpPr>
        <p:spPr bwMode="auto">
          <a:xfrm>
            <a:off x="188913" y="4160838"/>
            <a:ext cx="6411912" cy="61595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361950"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defTabSz="3619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defTabSz="36195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defTabSz="36195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defTabSz="36195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pl-PL" altLang="en-US" sz="800" b="1">
                <a:latin typeface="Arial" charset="0"/>
              </a:rPr>
              <a:t>Additional file </a:t>
            </a:r>
            <a:r>
              <a:rPr lang="pl-PL" altLang="en-US" sz="800" b="1" smtClean="0">
                <a:latin typeface="Arial" charset="0"/>
              </a:rPr>
              <a:t>6. </a:t>
            </a:r>
            <a:r>
              <a:rPr lang="pl-PL" altLang="en-US" sz="800" b="1">
                <a:latin typeface="Arial" charset="0"/>
              </a:rPr>
              <a:t>BiFC screening for interactions between subunits of the putative Arabidopsis ARP4-YAF9-SWC4 module.</a:t>
            </a:r>
            <a:r>
              <a:rPr lang="pl-PL" altLang="en-US" sz="800">
                <a:latin typeface="Arial" charset="0"/>
              </a:rPr>
              <a:t> All tested proteins were expressed in Arabidopsis mesophyll protoplasts transfected with PEG. Non-fluorescent fragments of EYFP were attached to their C-terminus. Full-length coding sequences were used in the case of AtARP4, AtYAF9A, AtYAF9B and AtSWC4. Each transfection consisted of a pair of complementary BiFC constructs (nEYFP and cEYFP fusion, right panels) and a ECFP construct as an internal transfection control (left panels). The scale bar in the upper left corner is 100 µm. </a:t>
            </a:r>
          </a:p>
        </p:txBody>
      </p:sp>
      <p:graphicFrame>
        <p:nvGraphicFramePr>
          <p:cNvPr id="26" name="Tabela 25"/>
          <p:cNvGraphicFramePr>
            <a:graphicFrameLocks noGrp="1"/>
          </p:cNvGraphicFramePr>
          <p:nvPr/>
        </p:nvGraphicFramePr>
        <p:xfrm>
          <a:off x="836613" y="704850"/>
          <a:ext cx="5764212" cy="36036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441053"/>
                <a:gridCol w="1441053"/>
                <a:gridCol w="1441053"/>
                <a:gridCol w="1441053"/>
              </a:tblGrid>
              <a:tr h="180182">
                <a:tc gridSpan="4"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YFP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 anchorCtr="1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7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 anchorCtr="1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7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 anchorCtr="1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7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 anchorCtr="1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0182">
                <a:tc>
                  <a:txBody>
                    <a:bodyPr/>
                    <a:lstStyle/>
                    <a:p>
                      <a:pPr algn="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ARP4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800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SWC4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800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YAF9A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800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YAF9B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8000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graphicFrame>
        <p:nvGraphicFramePr>
          <p:cNvPr id="27" name="Tabela 26"/>
          <p:cNvGraphicFramePr>
            <a:graphicFrameLocks noGrp="1"/>
          </p:cNvGraphicFramePr>
          <p:nvPr/>
        </p:nvGraphicFramePr>
        <p:xfrm>
          <a:off x="209963" y="1064568"/>
          <a:ext cx="575266" cy="291521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6702"/>
                <a:gridCol w="448564"/>
              </a:tblGrid>
              <a:tr h="728804">
                <a:tc rowSpan="4"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YFP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 anchorCtr="1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ARP4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 anchorCtr="1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728804">
                <a:tc vMerge="1"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vert="vert270" anchor="ctr" anchorCtr="1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SWC4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 anchorCtr="1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728804">
                <a:tc vMerge="1"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vert="vert270" anchor="ctr" anchorCtr="1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YAF9A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 anchorCtr="1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728804">
                <a:tc vMerge="1"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 vert="vert270" anchor="ctr" anchorCtr="1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YAF9B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 anchorCtr="1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127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02</TotalTime>
  <Words>111</Words>
  <Application>Microsoft Office PowerPoint</Application>
  <PresentationFormat>Papier A4 (210x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2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4" baseType="lpstr">
      <vt:lpstr>Arial</vt:lpstr>
      <vt:lpstr>Calibri</vt:lpstr>
      <vt:lpstr>Motyw pakietu Office</vt:lpstr>
      <vt:lpstr>Prezentacja programu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Tomek</dc:creator>
  <cp:lastModifiedBy>Tomek</cp:lastModifiedBy>
  <cp:revision>385</cp:revision>
  <cp:lastPrinted>2014-02-03T15:12:19Z</cp:lastPrinted>
  <dcterms:created xsi:type="dcterms:W3CDTF">2013-11-23T15:29:34Z</dcterms:created>
  <dcterms:modified xsi:type="dcterms:W3CDTF">2015-02-23T10:51:59Z</dcterms:modified>
</cp:coreProperties>
</file>